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62" r:id="rId2"/>
  </p:sldIdLst>
  <p:sldSz cx="9144000" cy="6858000" type="screen4x3"/>
  <p:notesSz cx="6735763" cy="9866313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969696"/>
    <a:srgbClr val="C0C0C0"/>
    <a:srgbClr val="EAEAEA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2195" autoAdjust="0"/>
    <p:restoredTop sz="94660"/>
  </p:normalViewPr>
  <p:slideViewPr>
    <p:cSldViewPr snapToGrid="0">
      <p:cViewPr varScale="1">
        <p:scale>
          <a:sx n="74" d="100"/>
          <a:sy n="74" d="100"/>
        </p:scale>
        <p:origin x="1296" y="6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AB368E-2406-43BF-91B4-17583E779D59}" type="datetimeFigureOut">
              <a:rPr kumimoji="1" lang="ja-JP" altLang="en-US" smtClean="0"/>
              <a:t>2020/12/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7EF55C-1F6D-47C0-A953-67CE5190817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7301201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AB368E-2406-43BF-91B4-17583E779D59}" type="datetimeFigureOut">
              <a:rPr kumimoji="1" lang="ja-JP" altLang="en-US" smtClean="0"/>
              <a:t>2020/12/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7EF55C-1F6D-47C0-A953-67CE5190817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8601628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AB368E-2406-43BF-91B4-17583E779D59}" type="datetimeFigureOut">
              <a:rPr kumimoji="1" lang="ja-JP" altLang="en-US" smtClean="0"/>
              <a:t>2020/12/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7EF55C-1F6D-47C0-A953-67CE5190817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5920088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AB368E-2406-43BF-91B4-17583E779D59}" type="datetimeFigureOut">
              <a:rPr kumimoji="1" lang="ja-JP" altLang="en-US" smtClean="0"/>
              <a:t>2020/12/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7EF55C-1F6D-47C0-A953-67CE5190817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449930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AB368E-2406-43BF-91B4-17583E779D59}" type="datetimeFigureOut">
              <a:rPr kumimoji="1" lang="ja-JP" altLang="en-US" smtClean="0"/>
              <a:t>2020/12/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7EF55C-1F6D-47C0-A953-67CE5190817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4561446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AB368E-2406-43BF-91B4-17583E779D59}" type="datetimeFigureOut">
              <a:rPr kumimoji="1" lang="ja-JP" altLang="en-US" smtClean="0"/>
              <a:t>2020/12/9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7EF55C-1F6D-47C0-A953-67CE5190817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2047357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AB368E-2406-43BF-91B4-17583E779D59}" type="datetimeFigureOut">
              <a:rPr kumimoji="1" lang="ja-JP" altLang="en-US" smtClean="0"/>
              <a:t>2020/12/9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7EF55C-1F6D-47C0-A953-67CE5190817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4223213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AB368E-2406-43BF-91B4-17583E779D59}" type="datetimeFigureOut">
              <a:rPr kumimoji="1" lang="ja-JP" altLang="en-US" smtClean="0"/>
              <a:t>2020/12/9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7EF55C-1F6D-47C0-A953-67CE5190817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981846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AB368E-2406-43BF-91B4-17583E779D59}" type="datetimeFigureOut">
              <a:rPr kumimoji="1" lang="ja-JP" altLang="en-US" smtClean="0"/>
              <a:t>2020/12/9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7EF55C-1F6D-47C0-A953-67CE5190817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8774283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AB368E-2406-43BF-91B4-17583E779D59}" type="datetimeFigureOut">
              <a:rPr kumimoji="1" lang="ja-JP" altLang="en-US" smtClean="0"/>
              <a:t>2020/12/9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7EF55C-1F6D-47C0-A953-67CE5190817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0132624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AB368E-2406-43BF-91B4-17583E779D59}" type="datetimeFigureOut">
              <a:rPr kumimoji="1" lang="ja-JP" altLang="en-US" smtClean="0"/>
              <a:t>2020/12/9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7EF55C-1F6D-47C0-A953-67CE5190817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5223869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3AB368E-2406-43BF-91B4-17583E779D59}" type="datetimeFigureOut">
              <a:rPr kumimoji="1" lang="ja-JP" altLang="en-US" smtClean="0"/>
              <a:t>2020/12/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E7EF55C-1F6D-47C0-A953-67CE5190817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9360233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8" name="Group 5">
            <a:extLst>
              <a:ext uri="{FF2B5EF4-FFF2-40B4-BE49-F238E27FC236}">
                <a16:creationId xmlns:a16="http://schemas.microsoft.com/office/drawing/2014/main" id="{96FE78AC-28D0-4119-B77E-B96FB92C09D8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760696167"/>
              </p:ext>
            </p:extLst>
          </p:nvPr>
        </p:nvGraphicFramePr>
        <p:xfrm>
          <a:off x="409801" y="594058"/>
          <a:ext cx="6673905" cy="6220398"/>
        </p:xfrm>
        <a:graphic>
          <a:graphicData uri="http://schemas.openxmlformats.org/drawingml/2006/table">
            <a:tbl>
              <a:tblPr/>
              <a:tblGrid>
                <a:gridCol w="1607485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1644902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496913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612162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  <a:gridCol w="529841">
                  <a:extLst>
                    <a:ext uri="{9D8B030D-6E8A-4147-A177-3AD203B41FA5}">
                      <a16:colId xmlns:a16="http://schemas.microsoft.com/office/drawing/2014/main" val="20004"/>
                    </a:ext>
                  </a:extLst>
                </a:gridCol>
                <a:gridCol w="320300">
                  <a:extLst>
                    <a:ext uri="{9D8B030D-6E8A-4147-A177-3AD203B41FA5}">
                      <a16:colId xmlns:a16="http://schemas.microsoft.com/office/drawing/2014/main" val="20005"/>
                    </a:ext>
                  </a:extLst>
                </a:gridCol>
                <a:gridCol w="612161">
                  <a:extLst>
                    <a:ext uri="{9D8B030D-6E8A-4147-A177-3AD203B41FA5}">
                      <a16:colId xmlns:a16="http://schemas.microsoft.com/office/drawing/2014/main" val="20006"/>
                    </a:ext>
                  </a:extLst>
                </a:gridCol>
                <a:gridCol w="529841">
                  <a:extLst>
                    <a:ext uri="{9D8B030D-6E8A-4147-A177-3AD203B41FA5}">
                      <a16:colId xmlns:a16="http://schemas.microsoft.com/office/drawing/2014/main" val="20007"/>
                    </a:ext>
                  </a:extLst>
                </a:gridCol>
                <a:gridCol w="320300">
                  <a:extLst>
                    <a:ext uri="{9D8B030D-6E8A-4147-A177-3AD203B41FA5}">
                      <a16:colId xmlns:a16="http://schemas.microsoft.com/office/drawing/2014/main" val="20008"/>
                    </a:ext>
                  </a:extLst>
                </a:gridCol>
              </a:tblGrid>
              <a:tr h="507391"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1" lang="ja-JP" altLang="ja-JP" sz="2600" b="0" i="0" u="none" strike="noStrike" cap="none" normalizeH="0" baseline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6211" marR="86211" marT="43106" marB="43106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1" lang="ja-JP" altLang="ja-JP" sz="26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6211" marR="86211" marT="43106" marB="43106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1" lang="ja-JP" altLang="ja-JP" sz="26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6211" marR="86211" marT="43106" marB="43106" anchor="ctr" horzOverflow="overflow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gridSpan="3"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 dirty="0" err="1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Peason's</a:t>
                      </a:r>
                      <a:r>
                        <a:rPr kumimoji="1" lang="en-US" altLang="ja-JP" sz="1000" b="0" i="0" u="none" strike="noStrike" cap="none" normalizeH="0" baseline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  Product-moment correlation</a:t>
                      </a:r>
                      <a:endParaRPr kumimoji="1" lang="en-US" altLang="ja-JP" sz="1700" b="0" i="0" u="none" strike="noStrike" cap="none" normalizeH="0" baseline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6211" marR="86211" marT="43106" marB="43106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gridSpan="3"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Spearman's rank difference correlation</a:t>
                      </a:r>
                      <a:endParaRPr kumimoji="1" lang="en-US" altLang="ja-JP" sz="17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6211" marR="86211" marT="43106" marB="43106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416090"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Variation 1</a:t>
                      </a:r>
                      <a:endParaRPr kumimoji="1" lang="en-US" altLang="ja-JP" sz="1700" b="0" i="0" u="none" strike="noStrike" cap="none" normalizeH="0" baseline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6211" marR="86211" marT="43106" marB="43106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Variation 2</a:t>
                      </a:r>
                      <a:endParaRPr kumimoji="1" lang="en-US" altLang="ja-JP" sz="1700" b="0" i="0" u="none" strike="noStrike" cap="none" normalizeH="0" baseline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6211" marR="86211" marT="43106" marB="43106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9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n</a:t>
                      </a:r>
                      <a:endParaRPr kumimoji="1" lang="en-US" altLang="ja-JP" sz="17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6211" marR="86211" marT="43106" marB="43106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ja-JP" altLang="en-US" sz="1000" b="1" i="0" u="none" strike="noStrike" cap="none" normalizeH="0" baseline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ｒ</a:t>
                      </a:r>
                      <a:endParaRPr kumimoji="1" lang="ja-JP" altLang="en-US" sz="1700" b="1" i="0" u="none" strike="noStrike" cap="none" normalizeH="0" baseline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6211" marR="86211" marT="43106" marB="43106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gridSpan="2"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P value</a:t>
                      </a:r>
                      <a:endParaRPr kumimoji="1" lang="en-US" altLang="ja-JP" sz="17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6211" marR="86211" marT="43106" marB="43106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ρ</a:t>
                      </a:r>
                      <a:endParaRPr kumimoji="1" lang="en-US" altLang="ja-JP" sz="17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6211" marR="86211" marT="43106" marB="43106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gridSpan="2"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P value</a:t>
                      </a:r>
                      <a:endParaRPr kumimoji="1" lang="en-US" altLang="ja-JP" sz="17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6211" marR="86211" marT="43106" marB="43106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251450"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tumor  volume %change</a:t>
                      </a:r>
                      <a:endParaRPr kumimoji="1" lang="en-US" altLang="ja-JP" sz="17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6211" marR="86211" marT="43106" marB="43106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PFS</a:t>
                      </a:r>
                      <a:endParaRPr kumimoji="1" lang="en-US" altLang="ja-JP" sz="17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6211" marR="86211" marT="43106" marB="43106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18 </a:t>
                      </a:r>
                      <a:endParaRPr kumimoji="1" lang="en-US" altLang="ja-JP" sz="17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6211" marR="86211" marT="43106" marB="43106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-0.668 </a:t>
                      </a:r>
                      <a:endParaRPr kumimoji="1" lang="en-US" altLang="ja-JP" sz="17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6211" marR="86211" marT="43106" marB="43106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0.002</a:t>
                      </a:r>
                      <a:endParaRPr kumimoji="1" lang="en-US" altLang="ja-JP" sz="17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6211" marR="86211" marT="43106" marB="43106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**</a:t>
                      </a:r>
                      <a:endParaRPr kumimoji="1" lang="en-US" altLang="ja-JP" sz="17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6211" marR="86211" marT="43106" marB="43106" anchor="ctr" horzOverflow="overflow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-0.568 </a:t>
                      </a:r>
                      <a:endParaRPr kumimoji="1" lang="en-US" altLang="ja-JP" sz="17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6211" marR="86211" marT="43106" marB="43106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0.019</a:t>
                      </a:r>
                      <a:endParaRPr kumimoji="1" lang="en-US" altLang="ja-JP" sz="17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6211" marR="86211" marT="43106" marB="43106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*</a:t>
                      </a:r>
                      <a:endParaRPr kumimoji="1" lang="en-US" altLang="ja-JP" sz="17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6211" marR="86211" marT="43106" marB="43106" anchor="ctr" horzOverflow="overflow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252947"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tumor  volume %change</a:t>
                      </a:r>
                      <a:endParaRPr kumimoji="1" lang="en-US" altLang="ja-JP" sz="17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6211" marR="86211" marT="43106" marB="43106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sCD26  Day 1  Post</a:t>
                      </a:r>
                      <a:endParaRPr kumimoji="1" lang="en-US" altLang="ja-JP" sz="17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6211" marR="86211" marT="43106" marB="43106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18 </a:t>
                      </a:r>
                      <a:endParaRPr kumimoji="1" lang="en-US" altLang="ja-JP" sz="17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6211" marR="86211" marT="43106" marB="43106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-0.147 </a:t>
                      </a:r>
                      <a:endParaRPr kumimoji="1" lang="en-US" altLang="ja-JP" sz="17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6211" marR="86211" marT="43106" marB="43106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0.566</a:t>
                      </a:r>
                      <a:endParaRPr kumimoji="1" lang="en-US" altLang="ja-JP" sz="17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6211" marR="86211" marT="43106" marB="43106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ja-JP" altLang="en-US" sz="10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　</a:t>
                      </a:r>
                      <a:endParaRPr kumimoji="1" lang="ja-JP" altLang="en-US" sz="17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6211" marR="86211" marT="43106" marB="43106" anchor="ctr" horzOverflow="overflow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-0.164 </a:t>
                      </a:r>
                      <a:endParaRPr kumimoji="1" lang="en-US" altLang="ja-JP" sz="17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6211" marR="86211" marT="43106" marB="43106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0.499</a:t>
                      </a:r>
                      <a:endParaRPr kumimoji="1" lang="en-US" altLang="ja-JP" sz="17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6211" marR="86211" marT="43106" marB="43106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ja-JP" altLang="en-US" sz="10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　</a:t>
                      </a:r>
                      <a:endParaRPr kumimoji="1" lang="ja-JP" altLang="en-US" sz="17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6211" marR="86211" marT="43106" marB="43106" anchor="ctr" horzOverflow="overflow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251450"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〃</a:t>
                      </a:r>
                      <a:endParaRPr kumimoji="1" lang="en-US" altLang="ja-JP" sz="17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6211" marR="86211" marT="43106" marB="43106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sCD26  Day15  Pre</a:t>
                      </a:r>
                      <a:endParaRPr kumimoji="1" lang="en-US" altLang="ja-JP" sz="17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6211" marR="86211" marT="43106" marB="43106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18 </a:t>
                      </a:r>
                      <a:endParaRPr kumimoji="1" lang="en-US" altLang="ja-JP" sz="17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6211" marR="86211" marT="43106" marB="43106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0.193 </a:t>
                      </a:r>
                      <a:endParaRPr kumimoji="1" lang="en-US" altLang="ja-JP" sz="17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6211" marR="86211" marT="43106" marB="43106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0.450</a:t>
                      </a:r>
                      <a:endParaRPr kumimoji="1" lang="en-US" altLang="ja-JP" sz="17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6211" marR="86211" marT="43106" marB="43106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ja-JP" altLang="en-US" sz="10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　</a:t>
                      </a:r>
                      <a:endParaRPr kumimoji="1" lang="ja-JP" altLang="en-US" sz="17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6211" marR="86211" marT="43106" marB="43106" anchor="ctr" horzOverflow="overflow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0.201 </a:t>
                      </a:r>
                      <a:endParaRPr kumimoji="1" lang="en-US" altLang="ja-JP" sz="17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6211" marR="86211" marT="43106" marB="43106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0.407</a:t>
                      </a:r>
                      <a:endParaRPr kumimoji="1" lang="en-US" altLang="ja-JP" sz="17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6211" marR="86211" marT="43106" marB="43106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ja-JP" altLang="en-US" sz="10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　</a:t>
                      </a:r>
                      <a:endParaRPr kumimoji="1" lang="ja-JP" altLang="en-US" sz="17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6211" marR="86211" marT="43106" marB="43106" anchor="ctr" horzOverflow="overflow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252947"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〃</a:t>
                      </a:r>
                      <a:endParaRPr kumimoji="1" lang="en-US" altLang="ja-JP" sz="17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6211" marR="86211" marT="43106" marB="43106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sCD26  Day15  Post</a:t>
                      </a:r>
                      <a:endParaRPr kumimoji="1" lang="en-US" altLang="ja-JP" sz="17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6211" marR="86211" marT="43106" marB="43106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18 </a:t>
                      </a:r>
                      <a:endParaRPr kumimoji="1" lang="en-US" altLang="ja-JP" sz="17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6211" marR="86211" marT="43106" marB="43106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0.030 </a:t>
                      </a:r>
                      <a:endParaRPr kumimoji="1" lang="en-US" altLang="ja-JP" sz="17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6211" marR="86211" marT="43106" marB="43106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0.908</a:t>
                      </a:r>
                      <a:endParaRPr kumimoji="1" lang="en-US" altLang="ja-JP" sz="17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6211" marR="86211" marT="43106" marB="43106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ja-JP" altLang="en-US" sz="10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　</a:t>
                      </a:r>
                      <a:endParaRPr kumimoji="1" lang="ja-JP" altLang="en-US" sz="17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6211" marR="86211" marT="43106" marB="43106" anchor="ctr" horzOverflow="overflow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-0.038 </a:t>
                      </a:r>
                      <a:endParaRPr kumimoji="1" lang="en-US" altLang="ja-JP" sz="17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6211" marR="86211" marT="43106" marB="43106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0.875</a:t>
                      </a:r>
                      <a:endParaRPr kumimoji="1" lang="en-US" altLang="ja-JP" sz="17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6211" marR="86211" marT="43106" marB="43106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ja-JP" altLang="en-US" sz="10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　</a:t>
                      </a:r>
                      <a:endParaRPr kumimoji="1" lang="ja-JP" altLang="en-US" sz="17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6211" marR="86211" marT="43106" marB="43106" anchor="ctr" horzOverflow="overflow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  <a:tr h="251450"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〃</a:t>
                      </a:r>
                      <a:endParaRPr kumimoji="1" lang="en-US" altLang="ja-JP" sz="17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6211" marR="86211" marT="43106" marB="43106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sCD26  Day29  Pre</a:t>
                      </a:r>
                      <a:endParaRPr kumimoji="1" lang="en-US" altLang="ja-JP" sz="17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6211" marR="86211" marT="43106" marB="43106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17 </a:t>
                      </a:r>
                      <a:endParaRPr kumimoji="1" lang="en-US" altLang="ja-JP" sz="17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6211" marR="86211" marT="43106" marB="43106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0.388 </a:t>
                      </a:r>
                      <a:endParaRPr kumimoji="1" lang="en-US" altLang="ja-JP" sz="17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6211" marR="86211" marT="43106" marB="43106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0.125</a:t>
                      </a:r>
                      <a:endParaRPr kumimoji="1" lang="en-US" altLang="ja-JP" sz="17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6211" marR="86211" marT="43106" marB="43106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ja-JP" altLang="en-US" sz="10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　</a:t>
                      </a:r>
                      <a:endParaRPr kumimoji="1" lang="ja-JP" altLang="en-US" sz="17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6211" marR="86211" marT="43106" marB="43106" anchor="ctr" horzOverflow="overflow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0.461 </a:t>
                      </a:r>
                      <a:endParaRPr kumimoji="1" lang="en-US" altLang="ja-JP" sz="17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6211" marR="86211" marT="43106" marB="43106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0.065</a:t>
                      </a:r>
                      <a:endParaRPr kumimoji="1" lang="en-US" altLang="ja-JP" sz="17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6211" marR="86211" marT="43106" marB="43106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ja-JP" altLang="en-US" sz="10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　</a:t>
                      </a:r>
                      <a:endParaRPr kumimoji="1" lang="ja-JP" altLang="en-US" sz="17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6211" marR="86211" marT="43106" marB="43106" anchor="ctr" horzOverflow="overflow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6"/>
                  </a:ext>
                </a:extLst>
              </a:tr>
              <a:tr h="252947"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〃</a:t>
                      </a:r>
                      <a:endParaRPr kumimoji="1" lang="en-US" altLang="ja-JP" sz="17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6211" marR="86211" marT="43106" marB="43106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sCD26  Day29  Post</a:t>
                      </a:r>
                      <a:endParaRPr kumimoji="1" lang="en-US" altLang="ja-JP" sz="17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6211" marR="86211" marT="43106" marB="43106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17 </a:t>
                      </a:r>
                      <a:endParaRPr kumimoji="1" lang="en-US" altLang="ja-JP" sz="17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6211" marR="86211" marT="43106" marB="43106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0.290 </a:t>
                      </a:r>
                      <a:endParaRPr kumimoji="1" lang="en-US" altLang="ja-JP" sz="17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6211" marR="86211" marT="43106" marB="43106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0.265</a:t>
                      </a:r>
                      <a:endParaRPr kumimoji="1" lang="en-US" altLang="ja-JP" sz="17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6211" marR="86211" marT="43106" marB="43106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ja-JP" altLang="en-US" sz="10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　</a:t>
                      </a:r>
                      <a:endParaRPr kumimoji="1" lang="ja-JP" altLang="en-US" sz="17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6211" marR="86211" marT="43106" marB="43106" anchor="ctr" horzOverflow="overflow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0.336 </a:t>
                      </a:r>
                      <a:endParaRPr kumimoji="1" lang="en-US" altLang="ja-JP" sz="17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6211" marR="86211" marT="43106" marB="43106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0.179</a:t>
                      </a:r>
                      <a:endParaRPr kumimoji="1" lang="en-US" altLang="ja-JP" sz="17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6211" marR="86211" marT="43106" marB="43106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ja-JP" altLang="en-US" sz="10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　</a:t>
                      </a:r>
                      <a:endParaRPr kumimoji="1" lang="ja-JP" altLang="en-US" sz="17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6211" marR="86211" marT="43106" marB="43106" anchor="ctr" horzOverflow="overflow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7"/>
                  </a:ext>
                </a:extLst>
              </a:tr>
              <a:tr h="251450"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〃</a:t>
                      </a:r>
                      <a:endParaRPr kumimoji="1" lang="en-US" altLang="ja-JP" sz="17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6211" marR="86211" marT="43106" marB="43106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DPP4  Day 1  Post</a:t>
                      </a:r>
                      <a:endParaRPr kumimoji="1" lang="en-US" altLang="ja-JP" sz="17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6211" marR="86211" marT="43106" marB="43106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18 </a:t>
                      </a:r>
                      <a:endParaRPr kumimoji="1" lang="en-US" altLang="ja-JP" sz="17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6211" marR="86211" marT="43106" marB="43106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0.060 </a:t>
                      </a:r>
                      <a:endParaRPr kumimoji="1" lang="en-US" altLang="ja-JP" sz="17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6211" marR="86211" marT="43106" marB="43106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0.817</a:t>
                      </a:r>
                      <a:endParaRPr kumimoji="1" lang="en-US" altLang="ja-JP" sz="17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6211" marR="86211" marT="43106" marB="43106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ja-JP" altLang="en-US" sz="10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　</a:t>
                      </a:r>
                      <a:endParaRPr kumimoji="1" lang="ja-JP" altLang="en-US" sz="17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6211" marR="86211" marT="43106" marB="43106" anchor="ctr" horzOverflow="overflow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-0.040 </a:t>
                      </a:r>
                      <a:endParaRPr kumimoji="1" lang="en-US" altLang="ja-JP" sz="17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6211" marR="86211" marT="43106" marB="43106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0.868</a:t>
                      </a:r>
                      <a:endParaRPr kumimoji="1" lang="en-US" altLang="ja-JP" sz="17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6211" marR="86211" marT="43106" marB="43106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ja-JP" altLang="en-US" sz="10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　</a:t>
                      </a:r>
                      <a:endParaRPr kumimoji="1" lang="ja-JP" altLang="en-US" sz="17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6211" marR="86211" marT="43106" marB="43106" anchor="ctr" horzOverflow="overflow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8"/>
                  </a:ext>
                </a:extLst>
              </a:tr>
              <a:tr h="252947"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〃</a:t>
                      </a:r>
                      <a:endParaRPr kumimoji="1" lang="en-US" altLang="ja-JP" sz="17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6211" marR="86211" marT="43106" marB="43106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DPP4  Day15  Pre</a:t>
                      </a:r>
                      <a:endParaRPr kumimoji="1" lang="en-US" altLang="ja-JP" sz="17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6211" marR="86211" marT="43106" marB="43106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18 </a:t>
                      </a:r>
                      <a:endParaRPr kumimoji="1" lang="en-US" altLang="ja-JP" sz="17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6211" marR="86211" marT="43106" marB="43106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0.230 </a:t>
                      </a:r>
                      <a:endParaRPr kumimoji="1" lang="en-US" altLang="ja-JP" sz="17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6211" marR="86211" marT="43106" marB="43106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0.365</a:t>
                      </a:r>
                      <a:endParaRPr kumimoji="1" lang="en-US" altLang="ja-JP" sz="17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6211" marR="86211" marT="43106" marB="43106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ja-JP" altLang="en-US" sz="10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　</a:t>
                      </a:r>
                      <a:endParaRPr kumimoji="1" lang="ja-JP" altLang="en-US" sz="17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6211" marR="86211" marT="43106" marB="43106" anchor="ctr" horzOverflow="overflow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0.207 </a:t>
                      </a:r>
                      <a:endParaRPr kumimoji="1" lang="en-US" altLang="ja-JP" sz="17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6211" marR="86211" marT="43106" marB="43106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0.392</a:t>
                      </a:r>
                      <a:endParaRPr kumimoji="1" lang="en-US" altLang="ja-JP" sz="17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6211" marR="86211" marT="43106" marB="43106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ja-JP" altLang="en-US" sz="10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　</a:t>
                      </a:r>
                      <a:endParaRPr kumimoji="1" lang="ja-JP" altLang="en-US" sz="17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6211" marR="86211" marT="43106" marB="43106" anchor="ctr" horzOverflow="overflow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9"/>
                  </a:ext>
                </a:extLst>
              </a:tr>
              <a:tr h="251450"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〃</a:t>
                      </a:r>
                      <a:endParaRPr kumimoji="1" lang="en-US" altLang="ja-JP" sz="17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6211" marR="86211" marT="43106" marB="43106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DPP4  Day15  Post</a:t>
                      </a:r>
                      <a:endParaRPr kumimoji="1" lang="en-US" altLang="ja-JP" sz="17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6211" marR="86211" marT="43106" marB="43106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18 </a:t>
                      </a:r>
                      <a:endParaRPr kumimoji="1" lang="en-US" altLang="ja-JP" sz="17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6211" marR="86211" marT="43106" marB="43106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0.135 </a:t>
                      </a:r>
                      <a:endParaRPr kumimoji="1" lang="en-US" altLang="ja-JP" sz="17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6211" marR="86211" marT="43106" marB="43106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0.599</a:t>
                      </a:r>
                      <a:endParaRPr kumimoji="1" lang="en-US" altLang="ja-JP" sz="17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6211" marR="86211" marT="43106" marB="43106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ja-JP" altLang="en-US" sz="10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　</a:t>
                      </a:r>
                      <a:endParaRPr kumimoji="1" lang="ja-JP" altLang="en-US" sz="17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6211" marR="86211" marT="43106" marB="43106" anchor="ctr" horzOverflow="overflow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0.137 </a:t>
                      </a:r>
                      <a:endParaRPr kumimoji="1" lang="en-US" altLang="ja-JP" sz="17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6211" marR="86211" marT="43106" marB="43106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0.572</a:t>
                      </a:r>
                      <a:endParaRPr kumimoji="1" lang="en-US" altLang="ja-JP" sz="17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6211" marR="86211" marT="43106" marB="43106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ja-JP" altLang="en-US" sz="10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　</a:t>
                      </a:r>
                      <a:endParaRPr kumimoji="1" lang="ja-JP" altLang="en-US" sz="17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6211" marR="86211" marT="43106" marB="43106" anchor="ctr" horzOverflow="overflow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10"/>
                  </a:ext>
                </a:extLst>
              </a:tr>
              <a:tr h="252947"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〃</a:t>
                      </a:r>
                      <a:endParaRPr kumimoji="1" lang="en-US" altLang="ja-JP" sz="17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6211" marR="86211" marT="43106" marB="43106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DPP4  Day29  Pre</a:t>
                      </a:r>
                      <a:endParaRPr kumimoji="1" lang="en-US" altLang="ja-JP" sz="17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6211" marR="86211" marT="43106" marB="43106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17 </a:t>
                      </a:r>
                      <a:endParaRPr kumimoji="1" lang="en-US" altLang="ja-JP" sz="17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6211" marR="86211" marT="43106" marB="43106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0.370 </a:t>
                      </a:r>
                      <a:endParaRPr kumimoji="1" lang="en-US" altLang="ja-JP" sz="17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6211" marR="86211" marT="43106" marB="43106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0.146</a:t>
                      </a:r>
                      <a:endParaRPr kumimoji="1" lang="en-US" altLang="ja-JP" sz="17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6211" marR="86211" marT="43106" marB="43106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ja-JP" altLang="en-US" sz="10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　</a:t>
                      </a:r>
                      <a:endParaRPr kumimoji="1" lang="ja-JP" altLang="en-US" sz="17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6211" marR="86211" marT="43106" marB="43106" anchor="ctr" horzOverflow="overflow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0.515 </a:t>
                      </a:r>
                      <a:endParaRPr kumimoji="1" lang="en-US" altLang="ja-JP" sz="17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6211" marR="86211" marT="43106" marB="43106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0.040</a:t>
                      </a:r>
                      <a:endParaRPr kumimoji="1" lang="en-US" altLang="ja-JP" sz="17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6211" marR="86211" marT="43106" marB="43106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*</a:t>
                      </a:r>
                      <a:endParaRPr kumimoji="1" lang="en-US" altLang="ja-JP" sz="17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6211" marR="86211" marT="43106" marB="43106" anchor="ctr" horzOverflow="overflow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11"/>
                  </a:ext>
                </a:extLst>
              </a:tr>
              <a:tr h="252947"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〃</a:t>
                      </a:r>
                      <a:endParaRPr kumimoji="1" lang="en-US" altLang="ja-JP" sz="17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6211" marR="86211" marT="43106" marB="43106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DPP4  Day29  Post</a:t>
                      </a:r>
                      <a:endParaRPr kumimoji="1" lang="en-US" altLang="ja-JP" sz="17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6211" marR="86211" marT="43106" marB="43106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17 </a:t>
                      </a:r>
                      <a:endParaRPr kumimoji="1" lang="en-US" altLang="ja-JP" sz="17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6211" marR="86211" marT="43106" marB="43106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0.371 </a:t>
                      </a:r>
                      <a:endParaRPr kumimoji="1" lang="en-US" altLang="ja-JP" sz="17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6211" marR="86211" marT="43106" marB="43106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0.145</a:t>
                      </a:r>
                      <a:endParaRPr kumimoji="1" lang="en-US" altLang="ja-JP" sz="17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6211" marR="86211" marT="43106" marB="43106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ja-JP" altLang="en-US" sz="10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　</a:t>
                      </a:r>
                      <a:endParaRPr kumimoji="1" lang="ja-JP" altLang="en-US" sz="17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6211" marR="86211" marT="43106" marB="43106" anchor="ctr" horzOverflow="overflow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0.593 </a:t>
                      </a:r>
                      <a:endParaRPr kumimoji="1" lang="en-US" altLang="ja-JP" sz="17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6211" marR="86211" marT="43106" marB="43106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0.018</a:t>
                      </a:r>
                      <a:endParaRPr kumimoji="1" lang="en-US" altLang="ja-JP" sz="17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6211" marR="86211" marT="43106" marB="43106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*</a:t>
                      </a:r>
                      <a:endParaRPr kumimoji="1" lang="en-US" altLang="ja-JP" sz="17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6211" marR="86211" marT="43106" marB="43106" anchor="ctr" horzOverflow="overflow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12"/>
                  </a:ext>
                </a:extLst>
              </a:tr>
              <a:tr h="251450"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PFS (days)</a:t>
                      </a:r>
                      <a:endParaRPr kumimoji="1" lang="en-US" altLang="ja-JP" sz="17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6211" marR="86211" marT="43106" marB="43106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sCD26  Day 1  Post</a:t>
                      </a:r>
                      <a:endParaRPr kumimoji="1" lang="en-US" altLang="ja-JP" sz="17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6211" marR="86211" marT="43106" marB="43106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19 </a:t>
                      </a:r>
                      <a:endParaRPr kumimoji="1" lang="en-US" altLang="ja-JP" sz="17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6211" marR="86211" marT="43106" marB="43106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0.100 </a:t>
                      </a:r>
                      <a:endParaRPr kumimoji="1" lang="en-US" altLang="ja-JP" sz="17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6211" marR="86211" marT="43106" marB="43106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0.688</a:t>
                      </a:r>
                      <a:endParaRPr kumimoji="1" lang="en-US" altLang="ja-JP" sz="17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6211" marR="86211" marT="43106" marB="43106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ja-JP" altLang="en-US" sz="10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　</a:t>
                      </a:r>
                      <a:endParaRPr kumimoji="1" lang="ja-JP" altLang="en-US" sz="17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6211" marR="86211" marT="43106" marB="43106" anchor="ctr" horzOverflow="overflow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0.137 </a:t>
                      </a:r>
                      <a:endParaRPr kumimoji="1" lang="en-US" altLang="ja-JP" sz="17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6211" marR="86211" marT="43106" marB="43106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0.563</a:t>
                      </a:r>
                      <a:endParaRPr kumimoji="1" lang="en-US" altLang="ja-JP" sz="17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6211" marR="86211" marT="43106" marB="43106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ja-JP" altLang="en-US" sz="10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　</a:t>
                      </a:r>
                      <a:endParaRPr kumimoji="1" lang="ja-JP" altLang="en-US" sz="17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6211" marR="86211" marT="43106" marB="43106" anchor="ctr" horzOverflow="overflow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13"/>
                  </a:ext>
                </a:extLst>
              </a:tr>
              <a:tr h="252947"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〃</a:t>
                      </a:r>
                      <a:endParaRPr kumimoji="1" lang="en-US" altLang="ja-JP" sz="17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6211" marR="86211" marT="43106" marB="43106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sCD26  Day15  Pre</a:t>
                      </a:r>
                      <a:endParaRPr kumimoji="1" lang="en-US" altLang="ja-JP" sz="17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6211" marR="86211" marT="43106" marB="43106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19 </a:t>
                      </a:r>
                      <a:endParaRPr kumimoji="1" lang="en-US" altLang="ja-JP" sz="17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6211" marR="86211" marT="43106" marB="43106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-0.150 </a:t>
                      </a:r>
                      <a:endParaRPr kumimoji="1" lang="en-US" altLang="ja-JP" sz="17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6211" marR="86211" marT="43106" marB="43106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0.546</a:t>
                      </a:r>
                      <a:endParaRPr kumimoji="1" lang="en-US" altLang="ja-JP" sz="17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6211" marR="86211" marT="43106" marB="43106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ja-JP" altLang="en-US" sz="10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　</a:t>
                      </a:r>
                      <a:endParaRPr kumimoji="1" lang="ja-JP" altLang="en-US" sz="17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6211" marR="86211" marT="43106" marB="43106" anchor="ctr" horzOverflow="overflow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-0.134 </a:t>
                      </a:r>
                      <a:endParaRPr kumimoji="1" lang="en-US" altLang="ja-JP" sz="17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6211" marR="86211" marT="43106" marB="43106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0.570</a:t>
                      </a:r>
                      <a:endParaRPr kumimoji="1" lang="en-US" altLang="ja-JP" sz="17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6211" marR="86211" marT="43106" marB="43106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ja-JP" altLang="en-US" sz="10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　</a:t>
                      </a:r>
                      <a:endParaRPr kumimoji="1" lang="ja-JP" altLang="en-US" sz="17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6211" marR="86211" marT="43106" marB="43106" anchor="ctr" horzOverflow="overflow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14"/>
                  </a:ext>
                </a:extLst>
              </a:tr>
              <a:tr h="251450"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〃</a:t>
                      </a:r>
                      <a:endParaRPr kumimoji="1" lang="en-US" altLang="ja-JP" sz="17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6211" marR="86211" marT="43106" marB="43106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sCD26  Day15  Post</a:t>
                      </a:r>
                      <a:endParaRPr kumimoji="1" lang="en-US" altLang="ja-JP" sz="17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6211" marR="86211" marT="43106" marB="43106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19 </a:t>
                      </a:r>
                      <a:endParaRPr kumimoji="1" lang="en-US" altLang="ja-JP" sz="17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6211" marR="86211" marT="43106" marB="43106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0.021 </a:t>
                      </a:r>
                      <a:endParaRPr kumimoji="1" lang="en-US" altLang="ja-JP" sz="17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6211" marR="86211" marT="43106" marB="43106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0.934</a:t>
                      </a:r>
                      <a:endParaRPr kumimoji="1" lang="en-US" altLang="ja-JP" sz="17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6211" marR="86211" marT="43106" marB="43106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ja-JP" altLang="en-US" sz="10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　</a:t>
                      </a:r>
                      <a:endParaRPr kumimoji="1" lang="ja-JP" altLang="en-US" sz="17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6211" marR="86211" marT="43106" marB="43106" anchor="ctr" horzOverflow="overflow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-0.056 </a:t>
                      </a:r>
                      <a:endParaRPr kumimoji="1" lang="en-US" altLang="ja-JP" sz="17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6211" marR="86211" marT="43106" marB="43106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0.811</a:t>
                      </a:r>
                      <a:endParaRPr kumimoji="1" lang="en-US" altLang="ja-JP" sz="17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6211" marR="86211" marT="43106" marB="43106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ja-JP" altLang="en-US" sz="10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　</a:t>
                      </a:r>
                      <a:endParaRPr kumimoji="1" lang="ja-JP" altLang="en-US" sz="17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6211" marR="86211" marT="43106" marB="43106" anchor="ctr" horzOverflow="overflow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15"/>
                  </a:ext>
                </a:extLst>
              </a:tr>
              <a:tr h="252947"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〃</a:t>
                      </a:r>
                      <a:endParaRPr kumimoji="1" lang="en-US" altLang="ja-JP" sz="17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6211" marR="86211" marT="43106" marB="43106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sCD26  Day29  Pre</a:t>
                      </a:r>
                      <a:endParaRPr kumimoji="1" lang="en-US" altLang="ja-JP" sz="17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6211" marR="86211" marT="43106" marB="43106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18 </a:t>
                      </a:r>
                      <a:endParaRPr kumimoji="1" lang="en-US" altLang="ja-JP" sz="17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6211" marR="86211" marT="43106" marB="43106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-0.328 </a:t>
                      </a:r>
                      <a:endParaRPr kumimoji="1" lang="en-US" altLang="ja-JP" sz="17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6211" marR="86211" marT="43106" marB="43106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0.187</a:t>
                      </a:r>
                      <a:endParaRPr kumimoji="1" lang="en-US" altLang="ja-JP" sz="17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6211" marR="86211" marT="43106" marB="43106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ja-JP" altLang="en-US" sz="10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　</a:t>
                      </a:r>
                      <a:endParaRPr kumimoji="1" lang="ja-JP" altLang="en-US" sz="17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6211" marR="86211" marT="43106" marB="43106" anchor="ctr" horzOverflow="overflow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-0.176 </a:t>
                      </a:r>
                      <a:endParaRPr kumimoji="1" lang="en-US" altLang="ja-JP" sz="17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6211" marR="86211" marT="43106" marB="43106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0.467</a:t>
                      </a:r>
                      <a:endParaRPr kumimoji="1" lang="en-US" altLang="ja-JP" sz="17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6211" marR="86211" marT="43106" marB="43106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ja-JP" altLang="en-US" sz="10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　</a:t>
                      </a:r>
                      <a:endParaRPr kumimoji="1" lang="ja-JP" altLang="en-US" sz="17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6211" marR="86211" marT="43106" marB="43106" anchor="ctr" horzOverflow="overflow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16"/>
                  </a:ext>
                </a:extLst>
              </a:tr>
              <a:tr h="251450"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〃</a:t>
                      </a:r>
                      <a:endParaRPr kumimoji="1" lang="en-US" altLang="ja-JP" sz="17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6211" marR="86211" marT="43106" marB="43106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sCD26  Day29  Post</a:t>
                      </a:r>
                      <a:endParaRPr kumimoji="1" lang="en-US" altLang="ja-JP" sz="17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6211" marR="86211" marT="43106" marB="43106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18 </a:t>
                      </a:r>
                      <a:endParaRPr kumimoji="1" lang="en-US" altLang="ja-JP" sz="17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6211" marR="86211" marT="43106" marB="43106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-0.527 </a:t>
                      </a:r>
                      <a:endParaRPr kumimoji="1" lang="en-US" altLang="ja-JP" sz="17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6211" marR="86211" marT="43106" marB="43106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0.023</a:t>
                      </a:r>
                      <a:endParaRPr kumimoji="1" lang="en-US" altLang="ja-JP" sz="17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6211" marR="86211" marT="43106" marB="43106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*</a:t>
                      </a:r>
                      <a:endParaRPr kumimoji="1" lang="en-US" altLang="ja-JP" sz="17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6211" marR="86211" marT="43106" marB="43106" anchor="ctr" horzOverflow="overflow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-0.354 </a:t>
                      </a:r>
                      <a:endParaRPr kumimoji="1" lang="en-US" altLang="ja-JP" sz="17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6211" marR="86211" marT="43106" marB="43106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0.145</a:t>
                      </a:r>
                      <a:endParaRPr kumimoji="1" lang="en-US" altLang="ja-JP" sz="17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6211" marR="86211" marT="43106" marB="43106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ja-JP" altLang="en-US" sz="10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　</a:t>
                      </a:r>
                      <a:endParaRPr kumimoji="1" lang="ja-JP" altLang="en-US" sz="17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6211" marR="86211" marT="43106" marB="43106" anchor="ctr" horzOverflow="overflow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17"/>
                  </a:ext>
                </a:extLst>
              </a:tr>
              <a:tr h="252947"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〃</a:t>
                      </a:r>
                      <a:endParaRPr kumimoji="1" lang="en-US" altLang="ja-JP" sz="17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6211" marR="86211" marT="43106" marB="43106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DPP4  Day 1  Post</a:t>
                      </a:r>
                      <a:endParaRPr kumimoji="1" lang="en-US" altLang="ja-JP" sz="17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6211" marR="86211" marT="43106" marB="43106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19 </a:t>
                      </a:r>
                      <a:endParaRPr kumimoji="1" lang="en-US" altLang="ja-JP" sz="17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6211" marR="86211" marT="43106" marB="43106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-0.138 </a:t>
                      </a:r>
                      <a:endParaRPr kumimoji="1" lang="en-US" altLang="ja-JP" sz="17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6211" marR="86211" marT="43106" marB="43106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0.578</a:t>
                      </a:r>
                      <a:endParaRPr kumimoji="1" lang="en-US" altLang="ja-JP" sz="17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6211" marR="86211" marT="43106" marB="43106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ja-JP" altLang="en-US" sz="10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　</a:t>
                      </a:r>
                      <a:endParaRPr kumimoji="1" lang="ja-JP" altLang="en-US" sz="17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6211" marR="86211" marT="43106" marB="43106" anchor="ctr" horzOverflow="overflow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-0.122 </a:t>
                      </a:r>
                      <a:endParaRPr kumimoji="1" lang="en-US" altLang="ja-JP" sz="17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6211" marR="86211" marT="43106" marB="43106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0.604</a:t>
                      </a:r>
                      <a:endParaRPr kumimoji="1" lang="en-US" altLang="ja-JP" sz="17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6211" marR="86211" marT="43106" marB="43106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ja-JP" altLang="en-US" sz="10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　</a:t>
                      </a:r>
                      <a:endParaRPr kumimoji="1" lang="ja-JP" altLang="en-US" sz="17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6211" marR="86211" marT="43106" marB="43106" anchor="ctr" horzOverflow="overflow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18"/>
                  </a:ext>
                </a:extLst>
              </a:tr>
              <a:tr h="251450"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〃</a:t>
                      </a:r>
                      <a:endParaRPr kumimoji="1" lang="en-US" altLang="ja-JP" sz="17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6211" marR="86211" marT="43106" marB="43106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DPP4  Day15  Pre</a:t>
                      </a:r>
                      <a:endParaRPr kumimoji="1" lang="en-US" altLang="ja-JP" sz="17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6211" marR="86211" marT="43106" marB="43106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19 </a:t>
                      </a:r>
                      <a:endParaRPr kumimoji="1" lang="en-US" altLang="ja-JP" sz="17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6211" marR="86211" marT="43106" marB="43106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-0.153 </a:t>
                      </a:r>
                      <a:endParaRPr kumimoji="1" lang="en-US" altLang="ja-JP" sz="17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6211" marR="86211" marT="43106" marB="43106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0.537</a:t>
                      </a:r>
                      <a:endParaRPr kumimoji="1" lang="en-US" altLang="ja-JP" sz="17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6211" marR="86211" marT="43106" marB="43106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ja-JP" altLang="en-US" sz="10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　</a:t>
                      </a:r>
                      <a:endParaRPr kumimoji="1" lang="ja-JP" altLang="en-US" sz="17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6211" marR="86211" marT="43106" marB="43106" anchor="ctr" horzOverflow="overflow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-0.140 </a:t>
                      </a:r>
                      <a:endParaRPr kumimoji="1" lang="en-US" altLang="ja-JP" sz="17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6211" marR="86211" marT="43106" marB="43106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0.553</a:t>
                      </a:r>
                      <a:endParaRPr kumimoji="1" lang="en-US" altLang="ja-JP" sz="17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6211" marR="86211" marT="43106" marB="43106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ja-JP" altLang="en-US" sz="10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　</a:t>
                      </a:r>
                      <a:endParaRPr kumimoji="1" lang="ja-JP" altLang="en-US" sz="17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6211" marR="86211" marT="43106" marB="43106" anchor="ctr" horzOverflow="overflow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19"/>
                  </a:ext>
                </a:extLst>
              </a:tr>
              <a:tr h="252947"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〃</a:t>
                      </a:r>
                      <a:endParaRPr kumimoji="1" lang="en-US" altLang="ja-JP" sz="17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6211" marR="86211" marT="43106" marB="43106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DPP4  Day15  Post</a:t>
                      </a:r>
                      <a:endParaRPr kumimoji="1" lang="en-US" altLang="ja-JP" sz="17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6211" marR="86211" marT="43106" marB="43106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19 </a:t>
                      </a:r>
                      <a:endParaRPr kumimoji="1" lang="en-US" altLang="ja-JP" sz="17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6211" marR="86211" marT="43106" marB="43106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-0.080 </a:t>
                      </a:r>
                      <a:endParaRPr kumimoji="1" lang="en-US" altLang="ja-JP" sz="17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6211" marR="86211" marT="43106" marB="43106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0.748</a:t>
                      </a:r>
                      <a:endParaRPr kumimoji="1" lang="en-US" altLang="ja-JP" sz="17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6211" marR="86211" marT="43106" marB="43106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ja-JP" altLang="en-US" sz="10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　</a:t>
                      </a:r>
                      <a:endParaRPr kumimoji="1" lang="ja-JP" altLang="en-US" sz="17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6211" marR="86211" marT="43106" marB="43106" anchor="ctr" horzOverflow="overflow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-0.179 </a:t>
                      </a:r>
                      <a:endParaRPr kumimoji="1" lang="en-US" altLang="ja-JP" sz="17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6211" marR="86211" marT="43106" marB="43106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0.448</a:t>
                      </a:r>
                      <a:endParaRPr kumimoji="1" lang="en-US" altLang="ja-JP" sz="17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6211" marR="86211" marT="43106" marB="43106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ja-JP" altLang="en-US" sz="10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　</a:t>
                      </a:r>
                      <a:endParaRPr kumimoji="1" lang="ja-JP" altLang="en-US" sz="17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6211" marR="86211" marT="43106" marB="43106" anchor="ctr" horzOverflow="overflow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20"/>
                  </a:ext>
                </a:extLst>
              </a:tr>
              <a:tr h="251450"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〃</a:t>
                      </a:r>
                      <a:endParaRPr kumimoji="1" lang="en-US" altLang="ja-JP" sz="17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6211" marR="86211" marT="43106" marB="43106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DPP4  Day29  Pre</a:t>
                      </a:r>
                      <a:endParaRPr kumimoji="1" lang="en-US" altLang="ja-JP" sz="17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6211" marR="86211" marT="43106" marB="43106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18 </a:t>
                      </a:r>
                      <a:endParaRPr kumimoji="1" lang="en-US" altLang="ja-JP" sz="17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6211" marR="86211" marT="43106" marB="43106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-0.251 </a:t>
                      </a:r>
                      <a:endParaRPr kumimoji="1" lang="en-US" altLang="ja-JP" sz="17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6211" marR="86211" marT="43106" marB="43106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0.320</a:t>
                      </a:r>
                      <a:endParaRPr kumimoji="1" lang="en-US" altLang="ja-JP" sz="17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6211" marR="86211" marT="43106" marB="43106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ja-JP" altLang="en-US" sz="10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　</a:t>
                      </a:r>
                      <a:endParaRPr kumimoji="1" lang="ja-JP" altLang="en-US" sz="17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6211" marR="86211" marT="43106" marB="43106" anchor="ctr" horzOverflow="overflow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-0.210 </a:t>
                      </a:r>
                      <a:endParaRPr kumimoji="1" lang="en-US" altLang="ja-JP" sz="17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6211" marR="86211" marT="43106" marB="43106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0.386</a:t>
                      </a:r>
                      <a:endParaRPr kumimoji="1" lang="en-US" altLang="ja-JP" sz="17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6211" marR="86211" marT="43106" marB="43106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ja-JP" altLang="en-US" sz="10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　</a:t>
                      </a:r>
                      <a:endParaRPr kumimoji="1" lang="ja-JP" altLang="en-US" sz="17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6211" marR="86211" marT="43106" marB="43106" anchor="ctr" horzOverflow="overflow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21"/>
                  </a:ext>
                </a:extLst>
              </a:tr>
              <a:tr h="252947"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〃</a:t>
                      </a:r>
                      <a:endParaRPr kumimoji="1" lang="en-US" altLang="ja-JP" sz="1700" b="0" i="0" u="none" strike="noStrike" cap="none" normalizeH="0" baseline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6211" marR="86211" marT="43106" marB="43106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DPP4  Day29  Post</a:t>
                      </a:r>
                      <a:endParaRPr kumimoji="1" lang="en-US" altLang="ja-JP" sz="17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6211" marR="86211" marT="43106" marB="43106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18 </a:t>
                      </a:r>
                      <a:endParaRPr kumimoji="1" lang="en-US" altLang="ja-JP" sz="17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6211" marR="86211" marT="43106" marB="43106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-0.457 </a:t>
                      </a:r>
                      <a:endParaRPr kumimoji="1" lang="en-US" altLang="ja-JP" sz="17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6211" marR="86211" marT="43106" marB="43106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0.056</a:t>
                      </a:r>
                      <a:endParaRPr kumimoji="1" lang="en-US" altLang="ja-JP" sz="17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6211" marR="86211" marT="43106" marB="43106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ja-JP" altLang="en-US" sz="10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　</a:t>
                      </a:r>
                      <a:endParaRPr kumimoji="1" lang="ja-JP" altLang="en-US" sz="17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6211" marR="86211" marT="43106" marB="43106" anchor="ctr" horzOverflow="overflow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-0.441 </a:t>
                      </a:r>
                      <a:endParaRPr kumimoji="1" lang="en-US" altLang="ja-JP" sz="1700" b="0" i="0" u="none" strike="noStrike" cap="none" normalizeH="0" baseline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6211" marR="86211" marT="43106" marB="43106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0.069</a:t>
                      </a:r>
                      <a:endParaRPr kumimoji="1" lang="en-US" altLang="ja-JP" sz="17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6211" marR="86211" marT="43106" marB="43106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ja-JP" altLang="en-US" sz="1000" b="0" i="0" u="none" strike="noStrike" cap="none" normalizeH="0" baseline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　</a:t>
                      </a:r>
                      <a:endParaRPr kumimoji="1" lang="ja-JP" altLang="en-US" sz="1700" b="0" i="0" u="none" strike="noStrike" cap="none" normalizeH="0" baseline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6211" marR="86211" marT="43106" marB="43106" anchor="ctr" horzOverflow="overflow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22"/>
                  </a:ext>
                </a:extLst>
              </a:tr>
            </a:tbl>
          </a:graphicData>
        </a:graphic>
      </p:graphicFrame>
      <p:sp>
        <p:nvSpPr>
          <p:cNvPr id="11" name="テキスト ボックス 10">
            <a:extLst>
              <a:ext uri="{FF2B5EF4-FFF2-40B4-BE49-F238E27FC236}">
                <a16:creationId xmlns:a16="http://schemas.microsoft.com/office/drawing/2014/main" id="{44B51841-EFA3-40A5-BC0A-302F09402A7C}"/>
              </a:ext>
            </a:extLst>
          </p:cNvPr>
          <p:cNvSpPr txBox="1"/>
          <p:nvPr/>
        </p:nvSpPr>
        <p:spPr>
          <a:xfrm>
            <a:off x="301801" y="12962"/>
            <a:ext cx="6144182" cy="49244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3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able S5. Correlation between serum sCD26/DPP4 titer variation (%) and tumor volume </a:t>
            </a:r>
          </a:p>
          <a:p>
            <a:r>
              <a:rPr kumimoji="1" lang="en-US" altLang="ja-JP" sz="13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hange (%) or PFS (days) in 19 MM cases by PPMC or SRDC analysis</a:t>
            </a:r>
            <a:endParaRPr kumimoji="1" lang="ja-JP" altLang="en-US" sz="13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98848283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978</TotalTime>
  <Words>314</Words>
  <Application>Microsoft Office PowerPoint</Application>
  <PresentationFormat>画面に合わせる (4:3)</PresentationFormat>
  <Paragraphs>200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5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7" baseType="lpstr">
      <vt:lpstr>Arial Unicode MS</vt:lpstr>
      <vt:lpstr>Arial</vt:lpstr>
      <vt:lpstr>Calibri</vt:lpstr>
      <vt:lpstr>Calibri Light</vt:lpstr>
      <vt:lpstr>Times New Roman</vt:lpstr>
      <vt:lpstr>Office テーマ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hatan</dc:creator>
  <cp:lastModifiedBy> </cp:lastModifiedBy>
  <cp:revision>51</cp:revision>
  <cp:lastPrinted>2020-10-09T00:45:33Z</cp:lastPrinted>
  <dcterms:created xsi:type="dcterms:W3CDTF">2020-04-13T08:26:21Z</dcterms:created>
  <dcterms:modified xsi:type="dcterms:W3CDTF">2020-12-08T18:16:56Z</dcterms:modified>
</cp:coreProperties>
</file>